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9" r:id="rId2"/>
    <p:sldId id="260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93" d="100"/>
          <a:sy n="93" d="100"/>
        </p:scale>
        <p:origin x="1208" y="-3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é Gadea Vacas" userId="d01cefd3-7751-49c9-b47b-cd1be3b1bdda" providerId="ADAL" clId="{35763B9B-BEFD-431F-B5C6-59A4BDCF4A15}"/>
    <pc:docChg chg="modSld">
      <pc:chgData name="José Gadea Vacas" userId="d01cefd3-7751-49c9-b47b-cd1be3b1bdda" providerId="ADAL" clId="{35763B9B-BEFD-431F-B5C6-59A4BDCF4A15}" dt="2025-10-12T18:40:49.161" v="161" actId="20577"/>
      <pc:docMkLst>
        <pc:docMk/>
      </pc:docMkLst>
      <pc:sldChg chg="modSp mod">
        <pc:chgData name="José Gadea Vacas" userId="d01cefd3-7751-49c9-b47b-cd1be3b1bdda" providerId="ADAL" clId="{35763B9B-BEFD-431F-B5C6-59A4BDCF4A15}" dt="2025-10-12T18:37:49.303" v="85" actId="20577"/>
        <pc:sldMkLst>
          <pc:docMk/>
          <pc:sldMk cId="4226175302" sldId="259"/>
        </pc:sldMkLst>
        <pc:spChg chg="mod">
          <ac:chgData name="José Gadea Vacas" userId="d01cefd3-7751-49c9-b47b-cd1be3b1bdda" providerId="ADAL" clId="{35763B9B-BEFD-431F-B5C6-59A4BDCF4A15}" dt="2025-10-12T18:37:19.387" v="54" actId="20577"/>
          <ac:spMkLst>
            <pc:docMk/>
            <pc:sldMk cId="4226175302" sldId="259"/>
            <ac:spMk id="14" creationId="{E80D9DFA-43EE-29E5-81BD-86CD9F2909A1}"/>
          </ac:spMkLst>
        </pc:spChg>
        <pc:spChg chg="mod">
          <ac:chgData name="José Gadea Vacas" userId="d01cefd3-7751-49c9-b47b-cd1be3b1bdda" providerId="ADAL" clId="{35763B9B-BEFD-431F-B5C6-59A4BDCF4A15}" dt="2025-10-12T18:37:49.303" v="85" actId="20577"/>
          <ac:spMkLst>
            <pc:docMk/>
            <pc:sldMk cId="4226175302" sldId="259"/>
            <ac:spMk id="18" creationId="{4E373E8F-F93F-BF37-CDD0-1FF5DBA4FBFA}"/>
          </ac:spMkLst>
        </pc:spChg>
      </pc:sldChg>
      <pc:sldChg chg="modSp mod">
        <pc:chgData name="José Gadea Vacas" userId="d01cefd3-7751-49c9-b47b-cd1be3b1bdda" providerId="ADAL" clId="{35763B9B-BEFD-431F-B5C6-59A4BDCF4A15}" dt="2025-10-12T18:40:49.161" v="161" actId="20577"/>
        <pc:sldMkLst>
          <pc:docMk/>
          <pc:sldMk cId="2843255617" sldId="260"/>
        </pc:sldMkLst>
        <pc:spChg chg="mod">
          <ac:chgData name="José Gadea Vacas" userId="d01cefd3-7751-49c9-b47b-cd1be3b1bdda" providerId="ADAL" clId="{35763B9B-BEFD-431F-B5C6-59A4BDCF4A15}" dt="2025-10-12T18:38:57.596" v="87" actId="20577"/>
          <ac:spMkLst>
            <pc:docMk/>
            <pc:sldMk cId="2843255617" sldId="260"/>
            <ac:spMk id="9" creationId="{DBD414C9-78F8-4D2A-EBE9-4B47CCF7F6AC}"/>
          </ac:spMkLst>
        </pc:spChg>
        <pc:spChg chg="mod">
          <ac:chgData name="José Gadea Vacas" userId="d01cefd3-7751-49c9-b47b-cd1be3b1bdda" providerId="ADAL" clId="{35763B9B-BEFD-431F-B5C6-59A4BDCF4A15}" dt="2025-10-12T18:40:49.161" v="161" actId="20577"/>
          <ac:spMkLst>
            <pc:docMk/>
            <pc:sldMk cId="2843255617" sldId="260"/>
            <ac:spMk id="23" creationId="{6A40C6A7-4692-D8B8-4EB4-E7F5CC42CD8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D05515-E3D9-4DE1-9589-B0C6FBFF4A62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30B800-A3E4-42D0-A77F-641EB4872CF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123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267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393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216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284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08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689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36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12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088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03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004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2FB1D3-9002-41A5-94CC-7688431B2157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25D495A-2169-47D4-ACEB-0F309CF2EF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629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57A7CBEF-63E3-0E0D-4718-B7816D208D65}"/>
              </a:ext>
            </a:extLst>
          </p:cNvPr>
          <p:cNvSpPr txBox="1"/>
          <p:nvPr/>
        </p:nvSpPr>
        <p:spPr>
          <a:xfrm>
            <a:off x="855844" y="2159675"/>
            <a:ext cx="506778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: Germination percentages before ageing of Arabidopsis accessions under four environmental conditions. Values are expressed as Mean ± SD. LL: low-light conditions. HL: high-light conditions.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80D9DFA-43EE-29E5-81BD-86CD9F2909A1}"/>
              </a:ext>
            </a:extLst>
          </p:cNvPr>
          <p:cNvSpPr txBox="1"/>
          <p:nvPr/>
        </p:nvSpPr>
        <p:spPr>
          <a:xfrm>
            <a:off x="1006183" y="4477248"/>
            <a:ext cx="529158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Correlation between P50 values and percentage of germination after harvesting. Data for all conditions and accessions were used for this analysis. Three biological replicates were performed per sample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E373E8F-F93F-BF37-CDD0-1FF5DBA4FBFA}"/>
              </a:ext>
            </a:extLst>
          </p:cNvPr>
          <p:cNvSpPr txBox="1"/>
          <p:nvPr/>
        </p:nvSpPr>
        <p:spPr>
          <a:xfrm>
            <a:off x="855844" y="6227469"/>
            <a:ext cx="548715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: DSDS50 values for seeds developed at 22ºC at LL or HL conditions. Values are shown in days ± SD of three biological replicates. LL: low-light; HL: high-light.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D03254E0-747E-6F6B-92B3-4F34C4544FE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14497" b="10064"/>
          <a:stretch>
            <a:fillRect/>
          </a:stretch>
        </p:blipFill>
        <p:spPr>
          <a:xfrm>
            <a:off x="1537585" y="7005846"/>
            <a:ext cx="3924299" cy="176639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87E632B-5702-FE1D-DEDE-77D11FC68D67}"/>
              </a:ext>
            </a:extLst>
          </p:cNvPr>
          <p:cNvSpPr txBox="1"/>
          <p:nvPr/>
        </p:nvSpPr>
        <p:spPr>
          <a:xfrm>
            <a:off x="752908" y="8772245"/>
            <a:ext cx="5487159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5: Combined effects estimated for differential gene expression in dry seeds developed under four environmental conditions 22ºC/LL, 22ºC/HL, 27ºC/LL and 27ºC/HL. Details are found in main text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659B971-AF70-02CB-FD8D-2C0682F643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1781552"/>
              </p:ext>
            </p:extLst>
          </p:nvPr>
        </p:nvGraphicFramePr>
        <p:xfrm>
          <a:off x="934369" y="514623"/>
          <a:ext cx="4989261" cy="1645920"/>
        </p:xfrm>
        <a:graphic>
          <a:graphicData uri="http://schemas.openxmlformats.org/drawingml/2006/table">
            <a:tbl>
              <a:tblPr firstRow="1" firstCol="1" bandRow="1"/>
              <a:tblGrid>
                <a:gridCol w="879767">
                  <a:extLst>
                    <a:ext uri="{9D8B030D-6E8A-4147-A177-3AD203B41FA5}">
                      <a16:colId xmlns:a16="http://schemas.microsoft.com/office/drawing/2014/main" val="2195527457"/>
                    </a:ext>
                  </a:extLst>
                </a:gridCol>
                <a:gridCol w="979852">
                  <a:extLst>
                    <a:ext uri="{9D8B030D-6E8A-4147-A177-3AD203B41FA5}">
                      <a16:colId xmlns:a16="http://schemas.microsoft.com/office/drawing/2014/main" val="2769095334"/>
                    </a:ext>
                  </a:extLst>
                </a:gridCol>
                <a:gridCol w="1077686">
                  <a:extLst>
                    <a:ext uri="{9D8B030D-6E8A-4147-A177-3AD203B41FA5}">
                      <a16:colId xmlns:a16="http://schemas.microsoft.com/office/drawing/2014/main" val="2958769770"/>
                    </a:ext>
                  </a:extLst>
                </a:gridCol>
                <a:gridCol w="1001486">
                  <a:extLst>
                    <a:ext uri="{9D8B030D-6E8A-4147-A177-3AD203B41FA5}">
                      <a16:colId xmlns:a16="http://schemas.microsoft.com/office/drawing/2014/main" val="445265939"/>
                    </a:ext>
                  </a:extLst>
                </a:gridCol>
                <a:gridCol w="1050470">
                  <a:extLst>
                    <a:ext uri="{9D8B030D-6E8A-4147-A177-3AD203B41FA5}">
                      <a16:colId xmlns:a16="http://schemas.microsoft.com/office/drawing/2014/main" val="2394059902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buNone/>
                      </a:pPr>
                      <a:endParaRPr lang="en-US" sz="10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°C/LL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°C/HL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°C</a:t>
                      </a:r>
                      <a:r>
                        <a:rPr lang="en-US" sz="1000" b="0" kern="100" dirty="0">
                          <a:solidFill>
                            <a:schemeClr val="tx1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L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°C</a:t>
                      </a:r>
                      <a:r>
                        <a:rPr lang="en-US" sz="1000" b="0" kern="100" dirty="0">
                          <a:solidFill>
                            <a:schemeClr val="tx1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L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269583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a-0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3.3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4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62453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t-0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284431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t-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.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7.3 ± 4.6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6.6 ± 2.8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41895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ol-0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6.6 ± 2.8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66979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r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4.6 ± 9.2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2.0 ± 4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4.6 ± 5.5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854849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u-A1-67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7.3 ± 4.6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35617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r-4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.6 ± 2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360847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or-4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 ± 0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3.3 ± 11.5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6.0 ± 4.0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1798622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A3D3F98-44D8-4E59-11D7-A606280835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4278229"/>
              </p:ext>
            </p:extLst>
          </p:nvPr>
        </p:nvGraphicFramePr>
        <p:xfrm>
          <a:off x="2235655" y="5082485"/>
          <a:ext cx="2528160" cy="1112520"/>
        </p:xfrm>
        <a:graphic>
          <a:graphicData uri="http://schemas.openxmlformats.org/drawingml/2006/table">
            <a:tbl>
              <a:tblPr firstRow="1" firstCol="1" bandRow="1"/>
              <a:tblGrid>
                <a:gridCol w="842720">
                  <a:extLst>
                    <a:ext uri="{9D8B030D-6E8A-4147-A177-3AD203B41FA5}">
                      <a16:colId xmlns:a16="http://schemas.microsoft.com/office/drawing/2014/main" val="2121502621"/>
                    </a:ext>
                  </a:extLst>
                </a:gridCol>
                <a:gridCol w="842720">
                  <a:extLst>
                    <a:ext uri="{9D8B030D-6E8A-4147-A177-3AD203B41FA5}">
                      <a16:colId xmlns:a16="http://schemas.microsoft.com/office/drawing/2014/main" val="1357231858"/>
                    </a:ext>
                  </a:extLst>
                </a:gridCol>
                <a:gridCol w="842720">
                  <a:extLst>
                    <a:ext uri="{9D8B030D-6E8A-4147-A177-3AD203B41FA5}">
                      <a16:colId xmlns:a16="http://schemas.microsoft.com/office/drawing/2014/main" val="316371524"/>
                    </a:ext>
                  </a:extLst>
                </a:gridCol>
              </a:tblGrid>
              <a:tr h="1981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buNone/>
                      </a:pPr>
                      <a:endParaRPr lang="en-US" sz="10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˚C/LL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˚C/HL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000644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a-0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.9 ± 1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.3 ± 0.4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919049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t-1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7.8 ± 0.3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.3 ± 0.9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571947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u-A1-67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.9 ± 1.6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.4 ± 0.4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410429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r-4</a:t>
                      </a:r>
                      <a:endParaRPr lang="en-US" sz="10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.8 ± 2.4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.3 ± 0.2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18563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or4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5.4 ± 0.5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.4 ± 0.4</a:t>
                      </a:r>
                      <a:endParaRPr lang="en-US" sz="10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527077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D7C91C8A-DE71-3B9A-49C9-045501B1F3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6918" y="2827702"/>
            <a:ext cx="2750042" cy="14775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61753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lage of different images of a butterfly&#10;&#10;AI-generated content may be incorrect.">
            <a:extLst>
              <a:ext uri="{FF2B5EF4-FFF2-40B4-BE49-F238E27FC236}">
                <a16:creationId xmlns:a16="http://schemas.microsoft.com/office/drawing/2014/main" id="{7E51A2FC-BD56-34FA-9D2E-5EBB1A3FB2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6119" y="1072056"/>
            <a:ext cx="2024075" cy="19406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5281F4E-0C55-5C97-4A08-9014A5AC5E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3008" y="1119353"/>
            <a:ext cx="1358121" cy="19406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BD792C5-8E08-1EF2-55E4-4DE8DAA4A881}"/>
              </a:ext>
            </a:extLst>
          </p:cNvPr>
          <p:cNvSpPr txBox="1"/>
          <p:nvPr/>
        </p:nvSpPr>
        <p:spPr>
          <a:xfrm>
            <a:off x="650440" y="933556"/>
            <a:ext cx="355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056F92-1736-38EE-DF88-5FAA111BA4D8}"/>
              </a:ext>
            </a:extLst>
          </p:cNvPr>
          <p:cNvSpPr txBox="1"/>
          <p:nvPr/>
        </p:nvSpPr>
        <p:spPr>
          <a:xfrm>
            <a:off x="3207205" y="933555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D414C9-78F8-4D2A-EBE9-4B47CCF7F6AC}"/>
              </a:ext>
            </a:extLst>
          </p:cNvPr>
          <p:cNvSpPr txBox="1"/>
          <p:nvPr/>
        </p:nvSpPr>
        <p:spPr>
          <a:xfrm>
            <a:off x="698029" y="3151156"/>
            <a:ext cx="5619598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Determination of mitochondrial superoxide levels. (a) Representative confocal images of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mbryos stained with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toSOX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, a mitochondrial superoxide indicator. Pseudo-colored red fluorescence indicates the presence of mitochondrial superoxide. Two columns are shown: the left column displays the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toSOX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uorescence alone, the right column shows the merged image of fluorescence and bright-field. The upper row shows an embryo from Bor-4 seeds developed at 22°C and subjected to 14 days of aging at 37 °C and 75% relative humidity. The lower row shows an embryo from Bor-4 seeds developed at 27°C and subjected to the same aging conditions.  (b) Quantification of mitochondrial superoxide levels based on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toSOX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uorescence intensity. Mean fluorescence intensity (MFI) was measured. Data are presented as mean ± SE (standard error). Statistical analysis revealed no significant differences between treatments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63D5553-8971-0181-0218-7499FD288BF8}"/>
              </a:ext>
            </a:extLst>
          </p:cNvPr>
          <p:cNvSpPr txBox="1"/>
          <p:nvPr/>
        </p:nvSpPr>
        <p:spPr>
          <a:xfrm>
            <a:off x="529229" y="4835328"/>
            <a:ext cx="355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48E9A42-E2F7-0765-DD5C-E979C925A779}"/>
              </a:ext>
            </a:extLst>
          </p:cNvPr>
          <p:cNvSpPr txBox="1"/>
          <p:nvPr/>
        </p:nvSpPr>
        <p:spPr>
          <a:xfrm>
            <a:off x="601917" y="6628843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BBDCA0D-6E1A-C847-7A1C-ABA5063E4F9E}"/>
              </a:ext>
            </a:extLst>
          </p:cNvPr>
          <p:cNvSpPr txBox="1"/>
          <p:nvPr/>
        </p:nvSpPr>
        <p:spPr>
          <a:xfrm>
            <a:off x="2867830" y="6628844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D4E0306-5697-3828-C5BE-2500FE798767}"/>
              </a:ext>
            </a:extLst>
          </p:cNvPr>
          <p:cNvSpPr txBox="1"/>
          <p:nvPr/>
        </p:nvSpPr>
        <p:spPr>
          <a:xfrm>
            <a:off x="2867830" y="481450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A40C6A7-4692-D8B8-4EB4-E7F5CC42CD8A}"/>
              </a:ext>
            </a:extLst>
          </p:cNvPr>
          <p:cNvSpPr txBox="1"/>
          <p:nvPr/>
        </p:nvSpPr>
        <p:spPr>
          <a:xfrm>
            <a:off x="534336" y="9040544"/>
            <a:ext cx="5623210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(a) Relative expression levels of the DOG1 gene. Expression levels (normalized read counts, mean of three biological replicates)  for (b) catalase genes, (c)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hydroascorbat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uctase genes, (d) glyoxalase genes. Data represent mean ± SD of three </a:t>
            </a:r>
            <a:r>
              <a:rPr lang="en-US" sz="100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replicates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significance was determined by two-way ANOVA followed by a Tukey test, with letters indicating significant differences (P&lt;0.05). 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D13CE677-176A-E0E3-5F90-5799A8CF65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6120" y="5000741"/>
            <a:ext cx="1585102" cy="140940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36E9DF4-DAC9-6FEB-7864-37B9EEEA4F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5032" y="6877824"/>
            <a:ext cx="1638569" cy="209767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51FCAF8-7228-02FD-E300-76964F9F70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19100" y="4952999"/>
            <a:ext cx="1595730" cy="203758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D47B62E-AC32-8B2C-3597-81D76554067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49931" y="7024633"/>
            <a:ext cx="2952892" cy="19478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3255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8</TotalTime>
  <Words>578</Words>
  <Application>Microsoft Office PowerPoint</Application>
  <PresentationFormat>A4 (210 x 297 mm)</PresentationFormat>
  <Paragraphs>73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pideh Mazhari Azad</dc:creator>
  <cp:lastModifiedBy>José Gadea Vacas</cp:lastModifiedBy>
  <cp:revision>70</cp:revision>
  <dcterms:created xsi:type="dcterms:W3CDTF">2025-07-20T09:05:25Z</dcterms:created>
  <dcterms:modified xsi:type="dcterms:W3CDTF">2025-10-12T18:40:53Z</dcterms:modified>
</cp:coreProperties>
</file>